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4" r:id="rId2"/>
  </p:sldIdLst>
  <p:sldSz cx="12192000" cy="6858000"/>
  <p:notesSz cx="6881813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886" autoAdjust="0"/>
    <p:restoredTop sz="92276" autoAdjust="0"/>
  </p:normalViewPr>
  <p:slideViewPr>
    <p:cSldViewPr snapToGrid="0">
      <p:cViewPr varScale="1">
        <p:scale>
          <a:sx n="89" d="100"/>
          <a:sy n="89" d="100"/>
        </p:scale>
        <p:origin x="110" y="245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sorterViewPr>
    <p:cViewPr>
      <p:scale>
        <a:sx n="126" d="100"/>
        <a:sy n="12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2913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97313" y="0"/>
            <a:ext cx="2982912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2EB08D0-07D1-4FCA-9739-7285C6712C70}" type="datetimeFigureOut">
              <a:rPr lang="en-US" smtClean="0"/>
              <a:t>8/21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54050" y="1162050"/>
            <a:ext cx="55753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8975" y="4473575"/>
            <a:ext cx="5505450" cy="3660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2982913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97313" y="8829675"/>
            <a:ext cx="2982912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4A335A4-D22F-4220-A92B-B9BF61066F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08936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3511E5-3772-40AB-872A-1A89D3A39A4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B1C81B7-40B7-4F8F-8BD0-0AA15256CA4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7E7419-88CE-4A8D-AFE8-64D41CC9BE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0F1A2-17BB-455D-A78D-B93EFC16ADF9}" type="datetimeFigureOut">
              <a:rPr lang="en-US" smtClean="0"/>
              <a:t>8/2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CF2CE16-9BC8-4F91-A3A5-C1DD495FC9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408440-F70F-4D83-B488-EA19E1705F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C3F440-1A41-40D4-9A80-0B8F84D996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8133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9AAB0E-873E-4A72-8996-58325FD295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584F6C1-A7B2-4F5D-B642-FF6BF5A7CD4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F0FE7D9-E22E-40D9-993D-89DA005C05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0F1A2-17BB-455D-A78D-B93EFC16ADF9}" type="datetimeFigureOut">
              <a:rPr lang="en-US" smtClean="0"/>
              <a:t>8/2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05492E-C4F2-4A52-B644-48E44E0B8F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D18BC3-CA0C-4E54-A556-19EAF8C078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C3F440-1A41-40D4-9A80-0B8F84D996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86853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BAEAE64-A6C8-4496-B54A-0785F62D7BE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F78FC39-6C3F-44A5-B707-7AF18D7805F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27312E-C61F-4974-AC58-487210C603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0F1A2-17BB-455D-A78D-B93EFC16ADF9}" type="datetimeFigureOut">
              <a:rPr lang="en-US" smtClean="0"/>
              <a:t>8/2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8EFAC5-EB6C-4B2C-A45E-6D093B33E0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E8DE9B-562E-493C-ABCF-5F33F6BAB8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C3F440-1A41-40D4-9A80-0B8F84D996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29932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D0A352-C5FD-4EFE-944E-2EB093206E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9F1879A-DFDB-4275-BE41-8E9D400804E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AF18339-6E36-40A4-94EA-70E46566B9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0F1A2-17BB-455D-A78D-B93EFC16ADF9}" type="datetimeFigureOut">
              <a:rPr lang="en-US" smtClean="0"/>
              <a:t>8/2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4C7E52-CD83-405B-B1B9-56EB7ADFB2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461D67-D46A-4FA5-85DE-272A2736FA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C3F440-1A41-40D4-9A80-0B8F84D996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22279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2B63FA-BF7E-48D1-A473-6813401A9A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2392FB2-870A-44CB-A263-B50CFE5C6BD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8D5B81-FC1C-49D2-8295-90E2A329DD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0F1A2-17BB-455D-A78D-B93EFC16ADF9}" type="datetimeFigureOut">
              <a:rPr lang="en-US" smtClean="0"/>
              <a:t>8/2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579BDA-BF16-49F2-B87C-E36F090F51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2982DAC-DC66-433B-9DF7-2C7D3D8354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C3F440-1A41-40D4-9A80-0B8F84D996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50638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D86169-166F-4272-BF78-44F83EBFAC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88BD9F8-A684-47DB-BA93-37355A8B213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822F5B8-3ECF-4E9D-92B4-C8D86B407E2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0691DE8-EAA4-46E3-B2C6-94F3ECC8A2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0F1A2-17BB-455D-A78D-B93EFC16ADF9}" type="datetimeFigureOut">
              <a:rPr lang="en-US" smtClean="0"/>
              <a:t>8/2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F4C53AC-C969-412C-BCC5-60D9111052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D858094-6D92-4652-AE06-589C26D9E2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C3F440-1A41-40D4-9A80-0B8F84D996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57292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65B880-588A-4020-B8FE-0B62388C86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43593CD-AA23-4D95-85E6-DA886FBB37E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35D0097-71EC-4C6F-996B-F373F479392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294B055-36A4-409B-AE1D-E840E947F10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2B0C06F-5F5C-4E04-98E7-E503EE9C019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872348E-D15A-4805-AC59-DF380BD0D8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0F1A2-17BB-455D-A78D-B93EFC16ADF9}" type="datetimeFigureOut">
              <a:rPr lang="en-US" smtClean="0"/>
              <a:t>8/21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37D6FEA-50CF-461C-8DAA-13108FBD7D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D7D9578-86FE-4605-9AA9-2F25DF6819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C3F440-1A41-40D4-9A80-0B8F84D996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31541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B75220-FA78-49F8-BB7E-88DBFAE92C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B8F14FE-9F66-4406-BDC9-8A24E54F77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0F1A2-17BB-455D-A78D-B93EFC16ADF9}" type="datetimeFigureOut">
              <a:rPr lang="en-US" smtClean="0"/>
              <a:t>8/21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95DB50D-4A3A-48F4-8168-6FA75F7D9C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5F240E0-E715-4EAB-BA52-D62CB52FBA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C3F440-1A41-40D4-9A80-0B8F84D996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06662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11029A0-4C99-4F26-9F6D-7E523132D1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0F1A2-17BB-455D-A78D-B93EFC16ADF9}" type="datetimeFigureOut">
              <a:rPr lang="en-US" smtClean="0"/>
              <a:t>8/21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36A45C0-9E4A-4417-A8EB-A3F4D80FC5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CA12FE3-DF8E-4408-8DC5-D4E58F8202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C3F440-1A41-40D4-9A80-0B8F84D996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06785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D16730-0810-45BC-81DE-3E112FE3A2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666836C-D5F3-4E66-AE6E-4BF60713350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EA0F478-6AAE-40CD-B4C3-1A03642956B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2BB5C71-72D8-450D-9106-6D100C370D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0F1A2-17BB-455D-A78D-B93EFC16ADF9}" type="datetimeFigureOut">
              <a:rPr lang="en-US" smtClean="0"/>
              <a:t>8/2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D44DE36-FE5D-4DE2-B856-34296EA59E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3FFF802-6D2D-4874-8996-AED6F7255B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C3F440-1A41-40D4-9A80-0B8F84D996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6333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8A712C-AABD-4E9C-AA78-64FCF0944D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C9F6720-053A-485B-9A96-670F80CA4C6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83B7C13-84FE-4D57-9B51-EF0815E4113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D374A54-1B62-4720-BBDB-31B4807680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30F1A2-17BB-455D-A78D-B93EFC16ADF9}" type="datetimeFigureOut">
              <a:rPr lang="en-US" smtClean="0"/>
              <a:t>8/21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9F09770-65EF-429F-A76D-A65AD78605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1A9DE4E-B379-4424-BED9-8B11ED6883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C3F440-1A41-40D4-9A80-0B8F84D996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45665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EE35207-D1FB-45E2-B788-63E502F344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6502CA1-5EF6-4DDB-B55E-AF27B8C416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F0CF55-47F0-4018-9AE4-B77803D66A0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30F1A2-17BB-455D-A78D-B93EFC16ADF9}" type="datetimeFigureOut">
              <a:rPr lang="en-US" smtClean="0"/>
              <a:t>8/21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37B262-F7E5-4BE1-A642-7AC135EE39D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7A93D6C-2A45-4028-85C3-E7D94264AF5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C3F440-1A41-40D4-9A80-0B8F84D996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14914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hyperlink" Target="https://www.pymol.org/" TargetMode="Externa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B05246B6-5ADA-405D-8C98-F4BC8AA2320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474001" y="91619"/>
            <a:ext cx="7101392" cy="283384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ED421299-2625-4572-9E00-15C81BC50BD7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</a:extLst>
          </a:blip>
          <a:srcRect r="2537"/>
          <a:stretch/>
        </p:blipFill>
        <p:spPr>
          <a:xfrm>
            <a:off x="4532642" y="3069597"/>
            <a:ext cx="7042751" cy="334596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CDEB5B0D-6E23-4230-A56C-C6A7B1B89AB2}"/>
              </a:ext>
            </a:extLst>
          </p:cNvPr>
          <p:cNvSpPr txBox="1"/>
          <p:nvPr/>
        </p:nvSpPr>
        <p:spPr>
          <a:xfrm>
            <a:off x="381000" y="423234"/>
            <a:ext cx="3517900" cy="24622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 Fig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tructural topology of the human COMT and DiMT proteins.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DBsu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redicted secondary structural topology of human COMT (PDB code: 3BWM). 3-D structure of human COMT (right side) displaying the arrangement of β-strands (order 3214576) and the overall fold of the enzyme.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DiMT protein's structural topology and 3-D structure displaying similar number of β-strands and arrangement of the overall fold of the human COMT protein structure. 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yMoL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0" i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b="0" i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  <a:hlinkClick r:id="rId6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https://www.pymol.org</a:t>
            </a:r>
            <a:r>
              <a:rPr lang="en-US" sz="1200" b="0" i="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s used to visualize β-strands within the 3-D structure of COMT and DiMT.</a:t>
            </a:r>
          </a:p>
          <a:p>
            <a:pPr algn="just"/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C2DF214-12A9-47B2-A6FD-DA4353271502}"/>
              </a:ext>
            </a:extLst>
          </p:cNvPr>
          <p:cNvSpPr txBox="1"/>
          <p:nvPr/>
        </p:nvSpPr>
        <p:spPr>
          <a:xfrm>
            <a:off x="4068521" y="42905"/>
            <a:ext cx="3468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58870B2-FB90-4376-80E1-49A0823C1D6C}"/>
              </a:ext>
            </a:extLst>
          </p:cNvPr>
          <p:cNvSpPr txBox="1"/>
          <p:nvPr/>
        </p:nvSpPr>
        <p:spPr>
          <a:xfrm>
            <a:off x="4068521" y="3009107"/>
            <a:ext cx="3468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2B3B326-5263-4116-9BCA-DEAB24D5A713}"/>
              </a:ext>
            </a:extLst>
          </p:cNvPr>
          <p:cNvSpPr txBox="1"/>
          <p:nvPr/>
        </p:nvSpPr>
        <p:spPr>
          <a:xfrm>
            <a:off x="9851695" y="292429"/>
            <a:ext cx="157655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Human COMT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2213E0D-0512-4B51-B667-3956BA315546}"/>
              </a:ext>
            </a:extLst>
          </p:cNvPr>
          <p:cNvSpPr txBox="1"/>
          <p:nvPr/>
        </p:nvSpPr>
        <p:spPr>
          <a:xfrm>
            <a:off x="9851695" y="3162995"/>
            <a:ext cx="128226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DiMT protein</a:t>
            </a:r>
          </a:p>
        </p:txBody>
      </p:sp>
    </p:spTree>
    <p:extLst>
      <p:ext uri="{BB962C8B-B14F-4D97-AF65-F5344CB8AC3E}">
        <p14:creationId xmlns:p14="http://schemas.microsoft.com/office/powerpoint/2010/main" val="9180488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50</TotalTime>
  <Words>113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a, Mukthar</dc:creator>
  <cp:lastModifiedBy>Witola, William Harold</cp:lastModifiedBy>
  <cp:revision>205</cp:revision>
  <cp:lastPrinted>2024-01-22T18:41:37Z</cp:lastPrinted>
  <dcterms:created xsi:type="dcterms:W3CDTF">2024-01-18T19:24:34Z</dcterms:created>
  <dcterms:modified xsi:type="dcterms:W3CDTF">2024-08-22T01:44:29Z</dcterms:modified>
</cp:coreProperties>
</file>